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0C405E-FB68-63BF-CD7A-94CB0E3083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015BF7-1005-2454-DD7B-40200C9FC5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5C47AE-BD5B-90DC-E71C-6548204DA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FACF1F-DAEB-D160-A696-DAD68DDAD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1F257-66A1-3B04-BA76-184FB384D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227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C3052-BB44-B1DD-A69A-106670E85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864762-90CC-A2EA-9AC5-80B4D85B89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E6598C-83A0-C180-E68D-65B1792B5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B3A652-C93D-F414-FB03-E307C1551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5E62B-9F3B-7FCA-37BE-FAC77267A7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749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0776574-42EC-9A23-C35B-462216142F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B2DF0A-7121-200B-8E82-4F6C77B6EF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DCE5B-7C0A-B441-0F01-25340CDF55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F496C6-5A0E-2C79-156E-332AFD171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49A067-4230-6259-A98A-8E2B5200C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627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041882-7CC9-3E06-E4E0-C6838BAB17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78F67B-E5BB-9CE0-CE6F-219AE29657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5615FD-1B04-A382-5762-48D2DC3E7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90039B-367A-3C8E-AB24-C06A06FB4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2C750C-B0A2-BF36-256D-C60A0F618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936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DF82A9-415A-7197-C9BB-26A32CE099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B3C05A-9DE2-F3CA-66B3-5BDF938D71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D95C38-9023-31EB-566C-466A76C0B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55AEEA-9FED-2F63-7E82-D41209C08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FC3CAF-CCF2-48C6-4282-DFD2D3558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008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19C049-7DD0-96F2-D561-BF6A54E5C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E0FA14-7E1A-DCD1-7C8B-023608F4FC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055D20-8AF8-7BAA-3F00-BE8DCC193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1CFFE8-15F3-3273-3D59-A198F5808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DA69A4-F07E-5549-EC83-EE09EA7A8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8271A8-4D99-9E3B-6889-4FEE3B114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474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438BBC-9EFD-8C5D-37D9-D6091C0AA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88B63D-1574-4953-A7C4-3862F1DC4B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24266E-1901-15E9-083A-E24144CBF4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BFC99E-03EF-AB32-0A5C-0F7B628E22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777DE15-92D2-F923-0A7D-D0F00D2FDC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7457E74-8EC5-EBFE-9164-D712A0256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F8584A-F48F-FE75-704B-E295725DF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7C79C5-1587-7C0E-72CA-BF56015CE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949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3D776-D670-D375-4200-0BA6E4E716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3A70EB-FCCC-7D13-7693-94FC96E56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D940D1-9E8A-23E1-0DC2-B0E47B9C6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3040AF-CAB0-4A3E-F746-F960337D3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18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3E81D8-5B1E-92C9-C699-F1BB4F410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393E5B-DDAA-5502-4F8F-A4C36C324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4128E7-17E3-FFED-069B-C22B8C15E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319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D868C-B778-6ACB-9193-65E7912E0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4AEABE-CD3A-58DB-AA76-35495AE4F4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3054BC-A0C4-4792-47A5-0F4F07F78F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64968F-4983-00F2-D841-1DFA2B3FF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644ED3-EE0D-BC2F-890D-37A16623CD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B670DA-383B-2965-F101-92EF7353C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569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CA5F6-BA4B-AF2D-E299-4EC91F0D4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99E47F-E0DB-48DA-71CC-4BA95BEF23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2A1A4D-C144-1001-4A28-060B13A313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DEDCA5-89BD-0581-876F-14F24FF41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88BA98-EF47-4B28-AEE1-3DE674AEA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CDBDB9-B746-5F23-9E85-B982268F1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28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3A72CC-A1AA-A325-ECD0-623D0D75F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6F93A41-A32C-035B-D7F3-008C4428A5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19AB08-3B10-A103-DD00-957C337716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CA7BA-9C01-1C4C-9280-CCD773D431B5}" type="datetimeFigureOut">
              <a:rPr lang="en-US" smtClean="0"/>
              <a:t>12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DEC8D0-7278-1830-FBE9-A79E31680D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F60C0D-9F02-2C87-E017-0511877866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CF525-CB19-DF4D-AF28-1121729324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703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A1D2C4B-AB66-E062-6E44-A7A273AE8E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5453865"/>
              </p:ext>
            </p:extLst>
          </p:nvPr>
        </p:nvGraphicFramePr>
        <p:xfrm>
          <a:off x="1550018" y="531087"/>
          <a:ext cx="2179502" cy="5029200"/>
        </p:xfrm>
        <a:graphic>
          <a:graphicData uri="http://schemas.openxmlformats.org/drawingml/2006/table">
            <a:tbl>
              <a:tblPr/>
              <a:tblGrid>
                <a:gridCol w="2179502">
                  <a:extLst>
                    <a:ext uri="{9D8B030D-6E8A-4147-A177-3AD203B41FA5}">
                      <a16:colId xmlns:a16="http://schemas.microsoft.com/office/drawing/2014/main" val="3757765551"/>
                    </a:ext>
                  </a:extLst>
                </a:gridCol>
              </a:tblGrid>
              <a:tr h="94594">
                <a:tc>
                  <a:txBody>
                    <a:bodyPr/>
                    <a:lstStyle/>
                    <a:p>
                      <a:r>
                        <a:rPr lang="en-GB" sz="1100" b="1">
                          <a:effectLst/>
                          <a:latin typeface="Calibri" panose="020F0502020204030204" pitchFamily="34" charset="0"/>
                        </a:rPr>
                        <a:t>CYTOF (Neutrophil staining)</a:t>
                      </a:r>
                      <a:endParaRPr lang="en-GB" sz="110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225395"/>
                  </a:ext>
                </a:extLst>
              </a:tr>
              <a:tr h="124332">
                <a:tc>
                  <a:txBody>
                    <a:bodyPr/>
                    <a:lstStyle/>
                    <a:p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</a:rPr>
                        <a:t>Marker (clone)-metal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66162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45 (HI30)-89Y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141966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5 (UCHT2)-111C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1160985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3 (UCHT1)-112C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478738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9 (HI91)-113C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876146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7 (CD7-6B7)-114C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444582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HLADR (L243)-116C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17964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49d (9F10)-141Pr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939408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9 (HIB19)-142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0495148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23 (6H6)-143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291796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5 (W6D3)-144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677238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38 (HIT2)-145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21900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64 (10.1)-146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252765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1c (Bu15)-147Sm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444510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6 (3G8)-148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599033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74 (LN2)-149Sm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28832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43 (84-3C1)-150N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692504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03 (Ber-ACT8)-151Eu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7060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66b (80H3)-152Sm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2674636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BDCA2 (201A)-153Eu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153673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63 (GHI/61)-154Sm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982042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36 (5-271)-155G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467502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0 (Hi10a)-156G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707452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33 (WM53)-158G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139907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22 (HIB22)-159T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830416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D14 (M5E2)-160Gd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939330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CLEC9A (8F9)-161Dy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08023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>
                          <a:effectLst/>
                          <a:latin typeface="Calibri" panose="020F0502020204030204" pitchFamily="34" charset="0"/>
                        </a:rPr>
                        <a:t>ki67 (B56)-162Dy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232467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72a/b (SE5A5)-163Dy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3133846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D62F03E-76D1-DB17-57F9-C2685DE326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7227752"/>
              </p:ext>
            </p:extLst>
          </p:nvPr>
        </p:nvGraphicFramePr>
        <p:xfrm>
          <a:off x="3916498" y="531087"/>
          <a:ext cx="2179502" cy="2514600"/>
        </p:xfrm>
        <a:graphic>
          <a:graphicData uri="http://schemas.openxmlformats.org/drawingml/2006/table">
            <a:tbl>
              <a:tblPr/>
              <a:tblGrid>
                <a:gridCol w="2179502">
                  <a:extLst>
                    <a:ext uri="{9D8B030D-6E8A-4147-A177-3AD203B41FA5}">
                      <a16:colId xmlns:a16="http://schemas.microsoft.com/office/drawing/2014/main" val="1180638836"/>
                    </a:ext>
                  </a:extLst>
                </a:gridCol>
              </a:tblGrid>
              <a:tr h="9459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dirty="0">
                          <a:effectLst/>
                          <a:latin typeface="Calibri" panose="020F0502020204030204" pitchFamily="34" charset="0"/>
                        </a:rPr>
                        <a:t>Marker (clone)-metal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3378159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 err="1">
                          <a:effectLst/>
                          <a:latin typeface="Calibri" panose="020F0502020204030204" pitchFamily="34" charset="0"/>
                        </a:rPr>
                        <a:t>Siglec</a:t>
                      </a:r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 8 (7C9)-164Dy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78564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01 (BB27)-165Ho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359695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41 (M80)-166Er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210228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301 (H037G3)-167Er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959062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71 (OKT9)-168Er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876634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BDCA4 (12C2)-169Tm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928632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14 (38660)-170Er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8299192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226 (DX11)-171Y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5405070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354 (TREM-26)-172Y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401825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371 (50C1)-173Y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2716201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42 (NY2)-174Y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921345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274 (29E.2A3)-175Lu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1732267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BDCA1 (L161)-176Yb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1993403"/>
                  </a:ext>
                </a:extLst>
              </a:tr>
              <a:tr h="94594">
                <a:tc>
                  <a:txBody>
                    <a:bodyPr/>
                    <a:lstStyle/>
                    <a:p>
                      <a:r>
                        <a:rPr lang="en-GB" sz="1100" dirty="0">
                          <a:effectLst/>
                          <a:latin typeface="Calibri" panose="020F0502020204030204" pitchFamily="34" charset="0"/>
                        </a:rPr>
                        <a:t>CD11b (ICRF44)-209Bi</a:t>
                      </a:r>
                    </a:p>
                  </a:txBody>
                  <a:tcPr marL="16423" marR="16423" marT="0" marB="0" anchor="ctr">
                    <a:lnL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BFBFB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520560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6DFB5A4-705D-3554-8CF7-BE3F40CD02EA}"/>
              </a:ext>
            </a:extLst>
          </p:cNvPr>
          <p:cNvSpPr txBox="1"/>
          <p:nvPr/>
        </p:nvSpPr>
        <p:spPr>
          <a:xfrm>
            <a:off x="3916498" y="3173689"/>
            <a:ext cx="24161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Table S6 </a:t>
            </a:r>
            <a:r>
              <a:rPr lang="en-US" sz="1200" dirty="0"/>
              <a:t>Metal-tagged antibody for </a:t>
            </a:r>
          </a:p>
          <a:p>
            <a:r>
              <a:rPr lang="en-US" sz="1200" dirty="0"/>
              <a:t>suspension CYTOF staining </a:t>
            </a:r>
          </a:p>
        </p:txBody>
      </p:sp>
    </p:spTree>
    <p:extLst>
      <p:ext uri="{BB962C8B-B14F-4D97-AF65-F5344CB8AC3E}">
        <p14:creationId xmlns:p14="http://schemas.microsoft.com/office/powerpoint/2010/main" val="2457608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40</Words>
  <Application>Microsoft Macintosh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 2013 - 2022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, Ling-Pei (RTH) OUH</dc:creator>
  <cp:lastModifiedBy>Ho, Ling-Pei (RTH) OUH</cp:lastModifiedBy>
  <cp:revision>1</cp:revision>
  <dcterms:created xsi:type="dcterms:W3CDTF">2022-12-20T14:11:37Z</dcterms:created>
  <dcterms:modified xsi:type="dcterms:W3CDTF">2022-12-20T14:14:28Z</dcterms:modified>
</cp:coreProperties>
</file>